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2" d="100"/>
          <a:sy n="82" d="100"/>
        </p:scale>
        <p:origin x="691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7ED791-E589-45C7-92EE-F78DB3E72CC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FC2B978-CD47-4FB6-B12E-B4A79192A24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6B83C8-1163-45AC-A51A-0981E24339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6DA9D-4D73-4667-813D-A7FE120C6440}" type="datetimeFigureOut">
              <a:rPr lang="en-GB" smtClean="0"/>
              <a:t>20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B307406-46FA-4D2F-A928-421C14F943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DC94C2-AA08-49B1-A6B2-B124ED8185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4C3D7-FE3C-4035-9B7C-0510B67045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63997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D3EC4C-422C-409B-A664-D8FAB6D457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748A9B4-0E24-4790-97BF-C5D6D67458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444B9C-89FC-428A-ABCA-68249F5E46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6DA9D-4D73-4667-813D-A7FE120C6440}" type="datetimeFigureOut">
              <a:rPr lang="en-GB" smtClean="0"/>
              <a:t>20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34D740-AEF5-4E06-AE7F-A00B299899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8A004C-0E41-44BF-B0A7-1812750E1D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4C3D7-FE3C-4035-9B7C-0510B67045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65707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24C0E16-4065-42FD-91F3-68FE612BEEE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D6F697C-9352-4B7C-A9F8-52497732BE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AD0960-AB28-45C4-8C78-2B2C582A6A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6DA9D-4D73-4667-813D-A7FE120C6440}" type="datetimeFigureOut">
              <a:rPr lang="en-GB" smtClean="0"/>
              <a:t>20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F5D805-FD05-4058-85A7-E6FF55FFFA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A4C2551-8003-4CB1-A30D-33096FA6C8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4C3D7-FE3C-4035-9B7C-0510B67045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28601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DA9626-DE10-4BFA-AEA6-6464E16399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803F4B-6422-4700-A432-139E423072B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77FE30-8A11-4DD8-9353-F8AE13911E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6DA9D-4D73-4667-813D-A7FE120C6440}" type="datetimeFigureOut">
              <a:rPr lang="en-GB" smtClean="0"/>
              <a:t>20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3A4B9E-98DE-48FA-BAA3-A60CBDF3E0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FF0732-B8BF-42AB-81E3-B34BE1D9A8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4C3D7-FE3C-4035-9B7C-0510B67045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715719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121E21-AE4B-42B1-92A0-ABDE00E5B5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F34105C-C6C3-4B7D-AD2B-EE2846B4FC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0A85F5-C902-466C-9AE8-D35C0F3F2F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6DA9D-4D73-4667-813D-A7FE120C6440}" type="datetimeFigureOut">
              <a:rPr lang="en-GB" smtClean="0"/>
              <a:t>20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1C08E5-0F1E-43E2-BE14-4AE90E4CCF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9BF2F1-ECF7-428A-BB8B-CA0B37867B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4C3D7-FE3C-4035-9B7C-0510B67045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263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5B91CB-2B9C-4411-90A3-E589D21261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94D355-97B4-49FF-9CAF-66D7175B34B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8C26A36-5C39-4212-BB6A-AAFF6A82A1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CB7B0B-BB6C-434D-94E1-B97B853D4D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6DA9D-4D73-4667-813D-A7FE120C6440}" type="datetimeFigureOut">
              <a:rPr lang="en-GB" smtClean="0"/>
              <a:t>20/08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EEEF370-75AB-4342-B2B4-27A5D20151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DF2883E-B991-4054-AC48-7F6F26892C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4C3D7-FE3C-4035-9B7C-0510B67045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28669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4D614B-ED3D-4AC5-95CD-C0ED2CC942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115027D-5E9E-4C3F-BA64-8B713D8401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5870D47-58F5-46BF-B189-EB4285F01B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7149623-1FCD-498E-AE9B-047E9F761B6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6D0DF5F-90BA-435D-B11F-CA3762EF39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18502CF-D38A-48A6-AC81-5934A9BEC3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6DA9D-4D73-4667-813D-A7FE120C6440}" type="datetimeFigureOut">
              <a:rPr lang="en-GB" smtClean="0"/>
              <a:t>20/08/2020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56AC612-04C0-4DCC-A0B7-5D160C6418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2F9777C-9215-453D-AB7B-54339BE644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4C3D7-FE3C-4035-9B7C-0510B67045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144902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2AD728-880D-4810-A3C5-274FEE6057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798BADA-EB8B-4F4A-AB59-58F5CE059C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6DA9D-4D73-4667-813D-A7FE120C6440}" type="datetimeFigureOut">
              <a:rPr lang="en-GB" smtClean="0"/>
              <a:t>20/08/2020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94D848E-D73A-4897-BDAD-FD0673CD7C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FCC0C0D-1E7A-4091-9F22-D3C8317DF2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4C3D7-FE3C-4035-9B7C-0510B67045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57410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78E9787-8477-445D-A135-FE42BAF1DA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6DA9D-4D73-4667-813D-A7FE120C6440}" type="datetimeFigureOut">
              <a:rPr lang="en-GB" smtClean="0"/>
              <a:t>20/08/2020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31EF03E-E4B4-4445-953C-D9849EABDC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9A917AE-8309-468A-B7CD-1C6538D9EF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4C3D7-FE3C-4035-9B7C-0510B67045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91381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13C836-E8AB-479E-B584-697BF8AAB7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E45F968-A1C4-46F9-8E2A-8A9C73829D3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D03437D-ABD9-4EA3-8584-DD99A106659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661CAFB-0FAD-4C3A-8208-46C091F7C8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6DA9D-4D73-4667-813D-A7FE120C6440}" type="datetimeFigureOut">
              <a:rPr lang="en-GB" smtClean="0"/>
              <a:t>20/08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26AA42-C331-4826-8ADC-2E1A5884B2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2841A72-953E-4DE7-9C46-542D6EF084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4C3D7-FE3C-4035-9B7C-0510B67045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13742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8E251C-B05D-4FBF-B6D7-2B9389AC23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DC74FD3-2F6C-49C7-B870-07FA332511A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8A6ED03-37F2-48F8-AD9E-8BC32F076F8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931826-D872-41D4-81F5-3FD3F2DCC3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66DA9D-4D73-4667-813D-A7FE120C6440}" type="datetimeFigureOut">
              <a:rPr lang="en-GB" smtClean="0"/>
              <a:t>20/08/2020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825790-9768-4E60-A2AB-1C4315D34D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F200DE-2D1E-4917-838E-0F43D1BAF0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4C3D7-FE3C-4035-9B7C-0510B67045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783104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F5E1BE7-34E0-4B86-9779-76EC5B56C1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5DCD9A6-4626-4224-A642-555C4F31B2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5B3F7D-7461-43B6-80D4-FB66A9554BD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66DA9D-4D73-4667-813D-A7FE120C6440}" type="datetimeFigureOut">
              <a:rPr lang="en-GB" smtClean="0"/>
              <a:t>20/08/2020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D17A16-87F0-4754-ACA7-FC270BA047F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06CC3E-A00A-4B9A-AE1E-0AD5CEC0E9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44C3D7-FE3C-4035-9B7C-0510B67045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55825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E4414618-CB01-4197-B642-49E7E608AEC4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379446" y="1026367"/>
            <a:ext cx="11262049" cy="533711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E5209C7-B2D8-4BA8-A12E-BB465B153054}"/>
              </a:ext>
            </a:extLst>
          </p:cNvPr>
          <p:cNvSpPr txBox="1"/>
          <p:nvPr/>
        </p:nvSpPr>
        <p:spPr>
          <a:xfrm>
            <a:off x="550505" y="177281"/>
            <a:ext cx="966651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Supplementary </a:t>
            </a:r>
            <a:r>
              <a:rPr lang="en-GB" b="1"/>
              <a:t>Figure 3. </a:t>
            </a:r>
            <a:endParaRPr lang="en-GB" b="1" dirty="0"/>
          </a:p>
          <a:p>
            <a:r>
              <a:rPr lang="en-GB" dirty="0"/>
              <a:t>Multivariate linear regression (1 independent, n dependent) analysis of different phytohormones searched in Google. 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F085B95F-A1ED-45D8-B663-6CA1A8CC1E33}"/>
              </a:ext>
            </a:extLst>
          </p:cNvPr>
          <p:cNvSpPr/>
          <p:nvPr/>
        </p:nvSpPr>
        <p:spPr>
          <a:xfrm>
            <a:off x="2906742" y="6311387"/>
            <a:ext cx="438870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/>
              <a:t>Regression of salicylic acid with </a:t>
            </a:r>
            <a:r>
              <a:rPr lang="en-GB" dirty="0" err="1"/>
              <a:t>strigolactone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7916855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7586DC3-37FC-4892-A311-B666451AE037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833535" y="1156997"/>
            <a:ext cx="10524930" cy="5337110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284AD63F-4853-4FE7-AC68-825DB89C05E2}"/>
              </a:ext>
            </a:extLst>
          </p:cNvPr>
          <p:cNvSpPr/>
          <p:nvPr/>
        </p:nvSpPr>
        <p:spPr>
          <a:xfrm>
            <a:off x="2906742" y="6311387"/>
            <a:ext cx="431541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/>
              <a:t>Regression of salicylic acid with abscisic acid</a:t>
            </a:r>
          </a:p>
        </p:txBody>
      </p:sp>
    </p:spTree>
    <p:extLst>
      <p:ext uri="{BB962C8B-B14F-4D97-AF65-F5344CB8AC3E}">
        <p14:creationId xmlns:p14="http://schemas.microsoft.com/office/powerpoint/2010/main" val="9736252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E94BC37-8DE1-4564-952E-F068BEC8EAA0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466530" y="671804"/>
            <a:ext cx="11075437" cy="5840963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331DD5A2-49F0-42A7-B45D-219941786084}"/>
              </a:ext>
            </a:extLst>
          </p:cNvPr>
          <p:cNvSpPr/>
          <p:nvPr/>
        </p:nvSpPr>
        <p:spPr>
          <a:xfrm>
            <a:off x="2906742" y="6311387"/>
            <a:ext cx="36737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/>
              <a:t>Regression of salicylic acid with auxin</a:t>
            </a:r>
          </a:p>
        </p:txBody>
      </p:sp>
    </p:spTree>
    <p:extLst>
      <p:ext uri="{BB962C8B-B14F-4D97-AF65-F5344CB8AC3E}">
        <p14:creationId xmlns:p14="http://schemas.microsoft.com/office/powerpoint/2010/main" val="17162166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00E1CEE-C47C-4500-B3B2-ED4C221E9EB9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149290" y="1101012"/>
            <a:ext cx="11821886" cy="5449078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D02D562A-9F82-451A-A61B-A269CEB13D85}"/>
              </a:ext>
            </a:extLst>
          </p:cNvPr>
          <p:cNvSpPr/>
          <p:nvPr/>
        </p:nvSpPr>
        <p:spPr>
          <a:xfrm>
            <a:off x="2906742" y="6311387"/>
            <a:ext cx="460119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/>
              <a:t>Regression of salicylic acid with </a:t>
            </a:r>
            <a:r>
              <a:rPr lang="en-GB" dirty="0" err="1"/>
              <a:t>brassinosteroid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3293683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5C2D6DF-09C3-495C-8EF5-50589A76440E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261256" y="363894"/>
            <a:ext cx="11569959" cy="6176865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F984C79F-062B-48A0-A24A-A7A8F7115618}"/>
              </a:ext>
            </a:extLst>
          </p:cNvPr>
          <p:cNvSpPr/>
          <p:nvPr/>
        </p:nvSpPr>
        <p:spPr>
          <a:xfrm>
            <a:off x="2906742" y="6311387"/>
            <a:ext cx="402052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/>
              <a:t>Regression of salicylic acid with cytokinin</a:t>
            </a:r>
          </a:p>
        </p:txBody>
      </p:sp>
    </p:spTree>
    <p:extLst>
      <p:ext uri="{BB962C8B-B14F-4D97-AF65-F5344CB8AC3E}">
        <p14:creationId xmlns:p14="http://schemas.microsoft.com/office/powerpoint/2010/main" val="1050195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BDDA2E02-C79E-4B4C-8AD0-00FA18FBF708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0" y="634482"/>
            <a:ext cx="11924522" cy="5906277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7E49EA63-1A59-49BE-B532-B5E4E8A03686}"/>
              </a:ext>
            </a:extLst>
          </p:cNvPr>
          <p:cNvSpPr/>
          <p:nvPr/>
        </p:nvSpPr>
        <p:spPr>
          <a:xfrm>
            <a:off x="2906742" y="6311387"/>
            <a:ext cx="398564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/>
              <a:t>Regression of salicylic acid with ethylene</a:t>
            </a:r>
          </a:p>
        </p:txBody>
      </p:sp>
    </p:spTree>
    <p:extLst>
      <p:ext uri="{BB962C8B-B14F-4D97-AF65-F5344CB8AC3E}">
        <p14:creationId xmlns:p14="http://schemas.microsoft.com/office/powerpoint/2010/main" val="131587838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0DE16F9-ECB5-40E7-9E44-5F45DC22F6B6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121298" y="830424"/>
            <a:ext cx="11859208" cy="5691673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25CA1980-01BC-4262-8904-74AB7F5A06A9}"/>
              </a:ext>
            </a:extLst>
          </p:cNvPr>
          <p:cNvSpPr/>
          <p:nvPr/>
        </p:nvSpPr>
        <p:spPr>
          <a:xfrm>
            <a:off x="2906742" y="6311387"/>
            <a:ext cx="41612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/>
              <a:t>Regression of salicylic acid with gibberellin</a:t>
            </a:r>
          </a:p>
        </p:txBody>
      </p:sp>
    </p:spTree>
    <p:extLst>
      <p:ext uri="{BB962C8B-B14F-4D97-AF65-F5344CB8AC3E}">
        <p14:creationId xmlns:p14="http://schemas.microsoft.com/office/powerpoint/2010/main" val="127579758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8118169-0641-4AD5-94EC-FC8C8BAA260F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102636" y="709126"/>
            <a:ext cx="11765902" cy="5971591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3A007F19-CAAA-4094-B0E9-D043B3402E80}"/>
              </a:ext>
            </a:extLst>
          </p:cNvPr>
          <p:cNvSpPr/>
          <p:nvPr/>
        </p:nvSpPr>
        <p:spPr>
          <a:xfrm>
            <a:off x="2990718" y="6488668"/>
            <a:ext cx="443679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/>
              <a:t>Regression of salicylic acid with jasmonic acid</a:t>
            </a:r>
          </a:p>
        </p:txBody>
      </p:sp>
    </p:spTree>
    <p:extLst>
      <p:ext uri="{BB962C8B-B14F-4D97-AF65-F5344CB8AC3E}">
        <p14:creationId xmlns:p14="http://schemas.microsoft.com/office/powerpoint/2010/main" val="33768208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72</Words>
  <Application>Microsoft Office PowerPoint</Application>
  <PresentationFormat>Widescreen</PresentationFormat>
  <Paragraphs>10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2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P</dc:creator>
  <cp:lastModifiedBy>HP</cp:lastModifiedBy>
  <cp:revision>5</cp:revision>
  <dcterms:created xsi:type="dcterms:W3CDTF">2020-07-21T13:44:26Z</dcterms:created>
  <dcterms:modified xsi:type="dcterms:W3CDTF">2020-08-20T11:23:30Z</dcterms:modified>
</cp:coreProperties>
</file>